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3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F80C18-9CC4-4C0E-922F-59E2074B201A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3B59CA-24CF-42AD-9FA0-A462F70FA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4231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9876F3-71BF-4919-B67A-48BEF25E1680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1400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27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27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3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45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157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1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2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1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30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463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84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82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3.e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4259" name="Picture 6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8320" y="1011086"/>
            <a:ext cx="2232000" cy="2821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609600" y="2293356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325984" y="2316287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203183" y="703255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2373609" y="2557574"/>
          <a:ext cx="1703821" cy="12905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2" name="SPW 12.0 Graph" r:id="rId5" imgW="4259552" imgH="3226315" progId="SigmaPlotGraphicObject.11">
                  <p:embed/>
                </p:oleObj>
              </mc:Choice>
              <mc:Fallback>
                <p:oleObj name="SPW 12.0 Graph" r:id="rId5" imgW="4259552" imgH="3226315" progId="SigmaPlotGraphicObject.11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73609" y="2557574"/>
                        <a:ext cx="1703821" cy="12905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504825" y="916727"/>
          <a:ext cx="1839150" cy="1305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3" name="SPW 12.0 Graph" r:id="rId7" imgW="4597875" imgH="3262711" progId="SigmaPlotGraphicObject.11">
                  <p:embed/>
                </p:oleObj>
              </mc:Choice>
              <mc:Fallback>
                <p:oleObj name="SPW 12.0 Graph" r:id="rId7" imgW="4597875" imgH="3262711" progId="SigmaPlotGraphicObject.11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04825" y="916727"/>
                        <a:ext cx="1839150" cy="1305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2249784" y="916727"/>
          <a:ext cx="1839150" cy="1305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4" name="SPW 12.0 Graph" r:id="rId9" imgW="4597875" imgH="3262711" progId="SigmaPlotGraphicObject.11">
                  <p:embed/>
                </p:oleObj>
              </mc:Choice>
              <mc:Fallback>
                <p:oleObj name="SPW 12.0 Graph" r:id="rId9" imgW="4597875" imgH="3262711" progId="SigmaPlotGraphicObject.11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49784" y="916727"/>
                        <a:ext cx="1839150" cy="1305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628650" y="2562225"/>
          <a:ext cx="1718408" cy="1305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SPW 12.0 Graph" r:id="rId11" imgW="4296020" imgH="3262711" progId="SigmaPlotGraphicObject.11">
                  <p:embed/>
                </p:oleObj>
              </mc:Choice>
              <mc:Fallback>
                <p:oleObj name="SPW 12.0 Graph" r:id="rId11" imgW="4296020" imgH="3262711" progId="SigmaPlotGraphicObject.11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28650" y="2562225"/>
                        <a:ext cx="1718408" cy="1305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609600" y="703255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325984" y="703255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 Box 105"/>
          <p:cNvSpPr txBox="1">
            <a:spLocks noChangeArrowheads="1"/>
          </p:cNvSpPr>
          <p:nvPr/>
        </p:nvSpPr>
        <p:spPr bwMode="auto">
          <a:xfrm>
            <a:off x="611484" y="4422530"/>
            <a:ext cx="5715000" cy="25511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4 Fig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espite sharing gp80 envelope with MLV, EcoHIV maintains HIV tropism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en days after EcoHIV or MLV infection of mice, the indicated tissues were harvested for measurement of viral nucleic acids by QPCR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2LTR circular DNA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grated viral DNA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plice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vi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NA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t 7 d after EcoHIV-EGFP or MLV-EGFP infection of mice, peritoneal cells were analyzed for F4/80 and intracellular EGFP expression.  Numbers in the flow plots indicates the percentage of gated cells expressing EGFP.  Red histograms are isotype controls.  BM=bone marrow, SP=spleen, PC=peritoneal cells, LN=lymph nodes, TH=thymus; LI=liver, LU=lung. </a:t>
            </a:r>
          </a:p>
        </p:txBody>
      </p:sp>
    </p:spTree>
    <p:extLst>
      <p:ext uri="{BB962C8B-B14F-4D97-AF65-F5344CB8AC3E}">
        <p14:creationId xmlns:p14="http://schemas.microsoft.com/office/powerpoint/2010/main" val="3678941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44</Words>
  <Application>Microsoft Office PowerPoint</Application>
  <PresentationFormat>Letter Paper (8.5x11 in)</PresentationFormat>
  <Paragraphs>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PW 12.0 Graph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Volsky</dc:creator>
  <cp:lastModifiedBy>David Volsky</cp:lastModifiedBy>
  <cp:revision>7</cp:revision>
  <dcterms:created xsi:type="dcterms:W3CDTF">2018-05-11T18:35:20Z</dcterms:created>
  <dcterms:modified xsi:type="dcterms:W3CDTF">2018-05-14T19:47:40Z</dcterms:modified>
</cp:coreProperties>
</file>